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D5D228E-2A28-4B05-849F-4B715EBAC377}" v="5" dt="2024-12-20T09:17:32.84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79" d="100"/>
          <a:sy n="79" d="100"/>
        </p:scale>
        <p:origin x="85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אלעד לקס/Elad Lax" userId="136e56fb-9293-434d-be9b-8f63d8a59b9b" providerId="ADAL" clId="{2D5D228E-2A28-4B05-849F-4B715EBAC377}"/>
    <pc:docChg chg="custSel addSld delSld modSld">
      <pc:chgData name="אלעד לקס/Elad Lax" userId="136e56fb-9293-434d-be9b-8f63d8a59b9b" providerId="ADAL" clId="{2D5D228E-2A28-4B05-849F-4B715EBAC377}" dt="2024-12-20T09:17:39.348" v="13" actId="47"/>
      <pc:docMkLst>
        <pc:docMk/>
      </pc:docMkLst>
      <pc:sldChg chg="addSp delSp modSp mod">
        <pc:chgData name="אלעד לקס/Elad Lax" userId="136e56fb-9293-434d-be9b-8f63d8a59b9b" providerId="ADAL" clId="{2D5D228E-2A28-4B05-849F-4B715EBAC377}" dt="2024-12-20T09:17:37.198" v="12" actId="12788"/>
        <pc:sldMkLst>
          <pc:docMk/>
          <pc:sldMk cId="387887843" sldId="272"/>
        </pc:sldMkLst>
        <pc:spChg chg="mod">
          <ac:chgData name="אלעד לקס/Elad Lax" userId="136e56fb-9293-434d-be9b-8f63d8a59b9b" providerId="ADAL" clId="{2D5D228E-2A28-4B05-849F-4B715EBAC377}" dt="2024-12-20T09:17:24.375" v="9" actId="164"/>
          <ac:spMkLst>
            <pc:docMk/>
            <pc:sldMk cId="387887843" sldId="272"/>
            <ac:spMk id="3" creationId="{649635B4-E2E7-2AFD-D0F1-DF9B022C51FF}"/>
          </ac:spMkLst>
        </pc:spChg>
        <pc:spChg chg="mod">
          <ac:chgData name="אלעד לקס/Elad Lax" userId="136e56fb-9293-434d-be9b-8f63d8a59b9b" providerId="ADAL" clId="{2D5D228E-2A28-4B05-849F-4B715EBAC377}" dt="2024-12-20T09:17:24.375" v="9" actId="164"/>
          <ac:spMkLst>
            <pc:docMk/>
            <pc:sldMk cId="387887843" sldId="272"/>
            <ac:spMk id="4" creationId="{B421B90D-CC64-C1EE-9BCE-DFA0193D93BF}"/>
          </ac:spMkLst>
        </pc:spChg>
        <pc:spChg chg="mod">
          <ac:chgData name="אלעד לקס/Elad Lax" userId="136e56fb-9293-434d-be9b-8f63d8a59b9b" providerId="ADAL" clId="{2D5D228E-2A28-4B05-849F-4B715EBAC377}" dt="2024-12-20T09:17:24.375" v="9" actId="164"/>
          <ac:spMkLst>
            <pc:docMk/>
            <pc:sldMk cId="387887843" sldId="272"/>
            <ac:spMk id="5" creationId="{77CCD150-7AD0-52FA-9AB1-B1F2D0BAA191}"/>
          </ac:spMkLst>
        </pc:spChg>
        <pc:spChg chg="mod">
          <ac:chgData name="אלעד לקס/Elad Lax" userId="136e56fb-9293-434d-be9b-8f63d8a59b9b" providerId="ADAL" clId="{2D5D228E-2A28-4B05-849F-4B715EBAC377}" dt="2024-12-20T09:17:24.375" v="9" actId="164"/>
          <ac:spMkLst>
            <pc:docMk/>
            <pc:sldMk cId="387887843" sldId="272"/>
            <ac:spMk id="6" creationId="{8746E5EC-5AD0-D67E-05A4-42AF135B7604}"/>
          </ac:spMkLst>
        </pc:spChg>
        <pc:spChg chg="mod">
          <ac:chgData name="אלעד לקס/Elad Lax" userId="136e56fb-9293-434d-be9b-8f63d8a59b9b" providerId="ADAL" clId="{2D5D228E-2A28-4B05-849F-4B715EBAC377}" dt="2024-12-20T09:17:24.375" v="9" actId="164"/>
          <ac:spMkLst>
            <pc:docMk/>
            <pc:sldMk cId="387887843" sldId="272"/>
            <ac:spMk id="7" creationId="{E0FD07BE-638A-1A31-6DB5-58762C21980C}"/>
          </ac:spMkLst>
        </pc:spChg>
        <pc:spChg chg="mod">
          <ac:chgData name="אלעד לקס/Elad Lax" userId="136e56fb-9293-434d-be9b-8f63d8a59b9b" providerId="ADAL" clId="{2D5D228E-2A28-4B05-849F-4B715EBAC377}" dt="2024-12-20T09:17:24.375" v="9" actId="164"/>
          <ac:spMkLst>
            <pc:docMk/>
            <pc:sldMk cId="387887843" sldId="272"/>
            <ac:spMk id="8" creationId="{AEAD4DC9-821F-11AB-847C-FE37D833CCA4}"/>
          </ac:spMkLst>
        </pc:spChg>
        <pc:spChg chg="add del mod">
          <ac:chgData name="אלעד לקס/Elad Lax" userId="136e56fb-9293-434d-be9b-8f63d8a59b9b" providerId="ADAL" clId="{2D5D228E-2A28-4B05-849F-4B715EBAC377}" dt="2024-12-20T09:17:10.253" v="6" actId="21"/>
          <ac:spMkLst>
            <pc:docMk/>
            <pc:sldMk cId="387887843" sldId="272"/>
            <ac:spMk id="9" creationId="{7C8E1B52-7C2E-BCCC-EF04-3B7F2564192C}"/>
          </ac:spMkLst>
        </pc:spChg>
        <pc:spChg chg="add mod">
          <ac:chgData name="אלעד לקס/Elad Lax" userId="136e56fb-9293-434d-be9b-8f63d8a59b9b" providerId="ADAL" clId="{2D5D228E-2A28-4B05-849F-4B715EBAC377}" dt="2024-12-20T09:17:37.198" v="12" actId="12788"/>
          <ac:spMkLst>
            <pc:docMk/>
            <pc:sldMk cId="387887843" sldId="272"/>
            <ac:spMk id="11" creationId="{8DF87E62-BD3B-02AD-40FF-FF2DE422FDF4}"/>
          </ac:spMkLst>
        </pc:spChg>
        <pc:grpChg chg="add mod">
          <ac:chgData name="אלעד לקס/Elad Lax" userId="136e56fb-9293-434d-be9b-8f63d8a59b9b" providerId="ADAL" clId="{2D5D228E-2A28-4B05-849F-4B715EBAC377}" dt="2024-12-20T09:17:27.873" v="10" actId="12788"/>
          <ac:grpSpMkLst>
            <pc:docMk/>
            <pc:sldMk cId="387887843" sldId="272"/>
            <ac:grpSpMk id="10" creationId="{BF766AC0-2058-243C-62EA-74483F825B2B}"/>
          </ac:grpSpMkLst>
        </pc:grpChg>
        <pc:graphicFrameChg chg="mod">
          <ac:chgData name="אלעד לקס/Elad Lax" userId="136e56fb-9293-434d-be9b-8f63d8a59b9b" providerId="ADAL" clId="{2D5D228E-2A28-4B05-849F-4B715EBAC377}" dt="2024-12-20T09:17:24.375" v="9" actId="164"/>
          <ac:graphicFrameMkLst>
            <pc:docMk/>
            <pc:sldMk cId="387887843" sldId="272"/>
            <ac:graphicFrameMk id="2" creationId="{407D1641-7817-E7DF-FC1A-85D9CB33F91E}"/>
          </ac:graphicFrameMkLst>
        </pc:graphicFrameChg>
      </pc:sldChg>
      <pc:sldChg chg="addSp delSp modSp add del mod">
        <pc:chgData name="אלעד לקס/Elad Lax" userId="136e56fb-9293-434d-be9b-8f63d8a59b9b" providerId="ADAL" clId="{2D5D228E-2A28-4B05-849F-4B715EBAC377}" dt="2024-12-20T09:17:39.348" v="13" actId="47"/>
        <pc:sldMkLst>
          <pc:docMk/>
          <pc:sldMk cId="1142265897" sldId="273"/>
        </pc:sldMkLst>
        <pc:spChg chg="add mod">
          <ac:chgData name="אלעד לקס/Elad Lax" userId="136e56fb-9293-434d-be9b-8f63d8a59b9b" providerId="ADAL" clId="{2D5D228E-2A28-4B05-849F-4B715EBAC377}" dt="2024-12-20T09:17:14.437" v="8"/>
          <ac:spMkLst>
            <pc:docMk/>
            <pc:sldMk cId="1142265897" sldId="273"/>
            <ac:spMk id="9" creationId="{7C8E1B52-7C2E-BCCC-EF04-3B7F2564192C}"/>
          </ac:spMkLst>
        </pc:spChg>
        <pc:spChg chg="del">
          <ac:chgData name="אלעד לקס/Elad Lax" userId="136e56fb-9293-434d-be9b-8f63d8a59b9b" providerId="ADAL" clId="{2D5D228E-2A28-4B05-849F-4B715EBAC377}" dt="2024-12-20T09:17:14.176" v="7" actId="478"/>
          <ac:spMkLst>
            <pc:docMk/>
            <pc:sldMk cId="1142265897" sldId="273"/>
            <ac:spMk id="15" creationId="{2284D940-C721-1ECC-B375-0887B393B797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B1D6B65-6057-4648-B150-220A51351362}" type="datetimeFigureOut">
              <a:rPr lang="en-US" smtClean="0"/>
              <a:t>12/20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A7EAA73-1441-4593-B22E-709D6A1FC6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28092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837343-F0BD-1D58-DFAB-DDC681CE3DC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D3416FE-1CAA-B696-49FF-B5C43229B52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805F70-8D5C-98AF-F913-F84145B80E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1F6685-20BA-4E1C-ACA2-BD8D22B8BD74}" type="datetimeFigureOut">
              <a:rPr lang="en-US" smtClean="0"/>
              <a:t>12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65A32E-62C5-106B-428E-9757D6B020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6D6DDE-3765-1282-B7F1-8120EFB7A1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0F95D1-7CC2-4F5C-9970-FB2CBC5FEC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21932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117225-E675-7465-79FD-3B01E024D2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A5D1744-852C-AFF7-CD50-FCD9FA93700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CB3F6E-3A36-3B32-136A-E39D9423CA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1F6685-20BA-4E1C-ACA2-BD8D22B8BD74}" type="datetimeFigureOut">
              <a:rPr lang="en-US" smtClean="0"/>
              <a:t>12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911B47-A090-3B13-AD9C-0025233E99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64479A-AC92-0F52-B1F2-CE12926FBF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0F95D1-7CC2-4F5C-9970-FB2CBC5FEC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29929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98474A1-360C-C468-820B-358FCBFABB0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B6FF8F6-CFBE-9B01-F5AF-3028F5ECD0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A0AFFA-2D28-B89E-5E51-B15D70A537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1F6685-20BA-4E1C-ACA2-BD8D22B8BD74}" type="datetimeFigureOut">
              <a:rPr lang="en-US" smtClean="0"/>
              <a:t>12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FD8E67-7E03-7457-E44B-79C9308C92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608EA9-D795-9EDC-F420-378DC174F3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0F95D1-7CC2-4F5C-9970-FB2CBC5FEC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46949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A6413A-3F87-827E-22B9-3645F41597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8D3F60F-3682-42AF-9AE7-E05F71DC278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6E5C48-F4B1-555F-11ED-EFBD8C1C3A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1F6685-20BA-4E1C-ACA2-BD8D22B8BD74}" type="datetimeFigureOut">
              <a:rPr lang="en-US" smtClean="0"/>
              <a:t>12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B2EB3A-58F4-AC06-0B5D-8E5BC047FF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73FDA0-B901-639F-87CC-2105242930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0F95D1-7CC2-4F5C-9970-FB2CBC5FEC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37331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CBABD4-D861-F59C-EBBE-5318352218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D5B82A-E065-1BAB-42A5-439D854618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11BD71-E924-010E-C89B-291EE41C42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1F6685-20BA-4E1C-ACA2-BD8D22B8BD74}" type="datetimeFigureOut">
              <a:rPr lang="en-US" smtClean="0"/>
              <a:t>12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A56990-8DB6-2103-F000-BC9D81E9D2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59C050-F2AB-9B63-4393-55CECAA77D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0F95D1-7CC2-4F5C-9970-FB2CBC5FEC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47556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B25A37-2DC6-9870-A06A-682F34C1ED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A088C32-D4DD-9032-3D94-1F8C030A01D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CE3F242-7426-F663-0AA1-D0D1CF74DAB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751E111-E058-D46F-697F-543F121E9D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1F6685-20BA-4E1C-ACA2-BD8D22B8BD74}" type="datetimeFigureOut">
              <a:rPr lang="en-US" smtClean="0"/>
              <a:t>12/2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05585CF-617C-AAAF-E9D3-A1ED5B33B8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90E5444-55E3-1826-A8A5-8581AE3E66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0F95D1-7CC2-4F5C-9970-FB2CBC5FEC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0863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D7DFBC-9A2A-00C4-9A62-840B73EA35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D8DD398-6C3D-0AB4-E05F-0E0D5A486E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F58D4D2-F60B-19DB-0FC9-50C7A764BF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E10B6E0-8F26-771B-9700-9BE31D7DC1D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3D1AE85-166E-3A4D-4E70-5CF63A41BC4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FC867D6-E401-2ED1-E7AB-D5AB0C2F8D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1F6685-20BA-4E1C-ACA2-BD8D22B8BD74}" type="datetimeFigureOut">
              <a:rPr lang="en-US" smtClean="0"/>
              <a:t>12/20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5403FEF-D4AD-5007-C65A-AB1A231A1D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74DCB17-0121-B65C-7335-6E4EDC77AF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0F95D1-7CC2-4F5C-9970-FB2CBC5FEC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30873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34206E-9626-FD87-94D8-67F3BB819D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FC11E5B-013F-FC85-0083-332382B3CA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1F6685-20BA-4E1C-ACA2-BD8D22B8BD74}" type="datetimeFigureOut">
              <a:rPr lang="en-US" smtClean="0"/>
              <a:t>12/20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B4173DE-F62B-FB77-96DA-597EC76EDC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797432E-8124-C89D-8FC4-FCAA4E2439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0F95D1-7CC2-4F5C-9970-FB2CBC5FEC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03668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F586D38-00C7-0A7E-D669-FBE4458B79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1F6685-20BA-4E1C-ACA2-BD8D22B8BD74}" type="datetimeFigureOut">
              <a:rPr lang="en-US" smtClean="0"/>
              <a:t>12/20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D2B376B-54C1-8777-2927-386E50ECDC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A36AB84-0AA5-0E62-1E49-B118662F42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0F95D1-7CC2-4F5C-9970-FB2CBC5FEC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77120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5681C8-6306-AF46-CE56-1ECCB71FDE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4932F8A-C351-18C2-F38D-8DCCD80D1F6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D11131F-926A-D245-7EE5-72D37C9184A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87C0FE-96D0-BF1C-49F8-2CBADCF316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1F6685-20BA-4E1C-ACA2-BD8D22B8BD74}" type="datetimeFigureOut">
              <a:rPr lang="en-US" smtClean="0"/>
              <a:t>12/2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0798CD2-523D-0955-CB96-D3FCC6158B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63DFF33-114F-8FCD-ADA6-10EE8E845C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0F95D1-7CC2-4F5C-9970-FB2CBC5FEC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46620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B37CEF-313E-4131-DC4C-E8C1DB594F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B09580E-B5C6-F8E7-0424-9FC212E36F8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C51D191-EEB3-2B1F-EB38-353DA2768C3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8161E31-499E-CE90-D80B-55DFABAB84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1F6685-20BA-4E1C-ACA2-BD8D22B8BD74}" type="datetimeFigureOut">
              <a:rPr lang="en-US" smtClean="0"/>
              <a:t>12/2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8B9FF47-C3D9-21FC-E7B7-D9EE5C7775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C848651-2750-3357-7E3F-587DC2B597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0F95D1-7CC2-4F5C-9970-FB2CBC5FEC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6634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C721E0A-E70A-3CF3-8FD1-55CB2B897A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A56CC5B-9FD5-B151-F519-4EFED8B312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01FB33-A15A-4B7B-E039-B4AF5D26379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51F6685-20BA-4E1C-ACA2-BD8D22B8BD74}" type="datetimeFigureOut">
              <a:rPr lang="en-US" smtClean="0"/>
              <a:t>12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D78411-0A2E-0CA2-5167-C025A603D6F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EA4EF1-6474-40F9-D427-0192A509128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D0F95D1-7CC2-4F5C-9970-FB2CBC5FEC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6449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>
            <a:extLst>
              <a:ext uri="{FF2B5EF4-FFF2-40B4-BE49-F238E27FC236}">
                <a16:creationId xmlns:a16="http://schemas.microsoft.com/office/drawing/2014/main" id="{BF766AC0-2058-243C-62EA-74483F825B2B}"/>
              </a:ext>
            </a:extLst>
          </p:cNvPr>
          <p:cNvGrpSpPr/>
          <p:nvPr/>
        </p:nvGrpSpPr>
        <p:grpSpPr>
          <a:xfrm>
            <a:off x="854926" y="266596"/>
            <a:ext cx="10482149" cy="6015142"/>
            <a:chOff x="1265285" y="266596"/>
            <a:chExt cx="10482149" cy="6015142"/>
          </a:xfrm>
        </p:grpSpPr>
        <p:graphicFrame>
          <p:nvGraphicFramePr>
            <p:cNvPr id="2" name="Object 1">
              <a:extLst>
                <a:ext uri="{FF2B5EF4-FFF2-40B4-BE49-F238E27FC236}">
                  <a16:creationId xmlns:a16="http://schemas.microsoft.com/office/drawing/2014/main" id="{407D1641-7817-E7DF-FC1A-85D9CB33F91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16660358"/>
                </p:ext>
              </p:extLst>
            </p:nvPr>
          </p:nvGraphicFramePr>
          <p:xfrm>
            <a:off x="1963672" y="576263"/>
            <a:ext cx="9783762" cy="57054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" imgW="9784277" imgH="5705392" progId="Prism10.Document">
                    <p:embed/>
                  </p:oleObj>
                </mc:Choice>
                <mc:Fallback>
                  <p:oleObj name="Prism 10" r:id="rId2" imgW="9784277" imgH="5705392" progId="Prism10.Document">
                    <p:embed/>
                    <p:pic>
                      <p:nvPicPr>
                        <p:cNvPr id="2" name="Object 1">
                          <a:extLst>
                            <a:ext uri="{FF2B5EF4-FFF2-40B4-BE49-F238E27FC236}">
                              <a16:creationId xmlns:a16="http://schemas.microsoft.com/office/drawing/2014/main" id="{407D1641-7817-E7DF-FC1A-85D9CB33F91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1963672" y="576263"/>
                          <a:ext cx="9783762" cy="57054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649635B4-E2E7-2AFD-D0F1-DF9B022C51FF}"/>
                </a:ext>
              </a:extLst>
            </p:cNvPr>
            <p:cNvSpPr txBox="1"/>
            <p:nvPr/>
          </p:nvSpPr>
          <p:spPr>
            <a:xfrm>
              <a:off x="3446829" y="266596"/>
              <a:ext cx="82203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5 min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B421B90D-CC64-C1EE-9BCE-DFA0193D93BF}"/>
                </a:ext>
              </a:extLst>
            </p:cNvPr>
            <p:cNvSpPr txBox="1"/>
            <p:nvPr/>
          </p:nvSpPr>
          <p:spPr>
            <a:xfrm>
              <a:off x="7682009" y="271215"/>
              <a:ext cx="82203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 hour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77CCD150-7AD0-52FA-9AB1-B1F2D0BAA191}"/>
                </a:ext>
              </a:extLst>
            </p:cNvPr>
            <p:cNvSpPr txBox="1"/>
            <p:nvPr/>
          </p:nvSpPr>
          <p:spPr>
            <a:xfrm>
              <a:off x="1265285" y="1394152"/>
              <a:ext cx="12561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-Fos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8746E5EC-5AD0-D67E-05A4-42AF135B7604}"/>
                </a:ext>
              </a:extLst>
            </p:cNvPr>
            <p:cNvSpPr txBox="1"/>
            <p:nvPr/>
          </p:nvSpPr>
          <p:spPr>
            <a:xfrm>
              <a:off x="3453314" y="4037696"/>
              <a:ext cx="82203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5 min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E0FD07BE-638A-1A31-6DB5-58762C21980C}"/>
                </a:ext>
              </a:extLst>
            </p:cNvPr>
            <p:cNvSpPr txBox="1"/>
            <p:nvPr/>
          </p:nvSpPr>
          <p:spPr>
            <a:xfrm>
              <a:off x="7688494" y="4042315"/>
              <a:ext cx="82203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 hour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AEAD4DC9-821F-11AB-847C-FE37D833CCA4}"/>
                </a:ext>
              </a:extLst>
            </p:cNvPr>
            <p:cNvSpPr txBox="1"/>
            <p:nvPr/>
          </p:nvSpPr>
          <p:spPr>
            <a:xfrm>
              <a:off x="1265285" y="5186849"/>
              <a:ext cx="12561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Egr1</a:t>
              </a:r>
            </a:p>
          </p:txBody>
        </p:sp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8DF87E62-BD3B-02AD-40FF-FF2DE422FDF4}"/>
              </a:ext>
            </a:extLst>
          </p:cNvPr>
          <p:cNvSpPr txBox="1"/>
          <p:nvPr/>
        </p:nvSpPr>
        <p:spPr>
          <a:xfrm>
            <a:off x="0" y="6171742"/>
            <a:ext cx="12192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endParaRPr lang="en-US" sz="1200" b="0" i="0" u="none" strike="noStrike" baseline="0" dirty="0">
              <a:solidFill>
                <a:srgbClr val="000000"/>
              </a:solidFill>
              <a:latin typeface="Arial" panose="020B0604020202020204" pitchFamily="34" charset="0"/>
            </a:endParaRPr>
          </a:p>
          <a:p>
            <a:r>
              <a:rPr lang="en-US" sz="1200" b="0" i="0" u="none" strike="noStrike" baseline="0" dirty="0">
                <a:solidFill>
                  <a:srgbClr val="000000"/>
                </a:solidFill>
                <a:latin typeface="Arial" panose="020B0604020202020204" pitchFamily="34" charset="0"/>
              </a:rPr>
              <a:t> </a:t>
            </a:r>
            <a:r>
              <a:rPr lang="en-US" sz="1200" b="1" i="0" u="none" strike="noStrike" baseline="0" dirty="0">
                <a:solidFill>
                  <a:srgbClr val="000000"/>
                </a:solidFill>
                <a:latin typeface="Arial" panose="020B0604020202020204" pitchFamily="34" charset="0"/>
              </a:rPr>
              <a:t>Supplementary Figure 2: 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</a:rPr>
              <a:t>Acetylation of histone 4 on </a:t>
            </a:r>
            <a:r>
              <a:rPr lang="en-US" sz="1200" b="1" dirty="0" err="1">
                <a:solidFill>
                  <a:srgbClr val="000000"/>
                </a:solidFill>
                <a:latin typeface="Arial" panose="020B0604020202020204" pitchFamily="34" charset="0"/>
              </a:rPr>
              <a:t>cFos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</a:rPr>
              <a:t> and Egr1</a:t>
            </a:r>
            <a:r>
              <a:rPr lang="en-US" sz="1200" b="1" i="0" u="none" strike="noStrike" baseline="0" dirty="0">
                <a:solidFill>
                  <a:srgbClr val="000000"/>
                </a:solidFill>
                <a:latin typeface="Arial" panose="020B0604020202020204" pitchFamily="34" charset="0"/>
              </a:rPr>
              <a:t> promoters. </a:t>
            </a:r>
            <a:r>
              <a:rPr lang="en-US" sz="1200" b="0" i="0" u="none" strike="noStrike" baseline="0" dirty="0">
                <a:solidFill>
                  <a:srgbClr val="000000"/>
                </a:solidFill>
                <a:latin typeface="Arial" panose="020B0604020202020204" pitchFamily="34" charset="0"/>
              </a:rPr>
              <a:t>Acetylated H4 enrichment on Egr1 promoter was reduced 1 hour, but not 15 minutes, after the FST in ABT888 pretreated mice. A strong trend towards reduced enrichment was observed for </a:t>
            </a:r>
            <a:r>
              <a:rPr lang="en-US" sz="1200" b="0" i="0" u="none" strike="noStrike" baseline="0" dirty="0" err="1">
                <a:solidFill>
                  <a:srgbClr val="000000"/>
                </a:solidFill>
                <a:latin typeface="Arial" panose="020B0604020202020204" pitchFamily="34" charset="0"/>
              </a:rPr>
              <a:t>cFos</a:t>
            </a:r>
            <a:r>
              <a:rPr lang="en-US" sz="1200" b="0" i="0" u="none" strike="noStrike" baseline="0" dirty="0">
                <a:solidFill>
                  <a:srgbClr val="000000"/>
                </a:solidFill>
                <a:latin typeface="Arial" panose="020B0604020202020204" pitchFamily="34" charset="0"/>
              </a:rPr>
              <a:t> 1 hour after the FST. T-test, ***p&lt;0.001, n=4-6 per group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878878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78</Words>
  <Application>Microsoft Office PowerPoint</Application>
  <PresentationFormat>Widescreen</PresentationFormat>
  <Paragraphs>8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rism 10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אלעד לקס/Elad Lax</dc:creator>
  <cp:lastModifiedBy>אלעד לקס/Elad Lax</cp:lastModifiedBy>
  <cp:revision>1</cp:revision>
  <dcterms:created xsi:type="dcterms:W3CDTF">2024-12-19T22:54:38Z</dcterms:created>
  <dcterms:modified xsi:type="dcterms:W3CDTF">2024-12-20T09:17:41Z</dcterms:modified>
</cp:coreProperties>
</file>